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D742C7-1513-43E0-A8C7-43E96EDCEB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FF1907-7003-46F1-8908-17E0522AF2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7EE81-FEF7-4AF6-AA07-5C300C31A6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CC515B-35B3-425F-B8CE-12F2BE06B6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53A94-B0B7-494B-8B78-F4177A0959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E8C7B-CD33-4C77-827A-EB35A64AFD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AFC09-0020-4BD9-BA08-5A49541293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B0269-271D-4E29-B96C-E4192DB762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509DF-AEC5-4ABD-97DC-2BEAB97CEF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ABB19-E652-4D73-AC5B-943CA6A351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F67E5-AC2E-423E-84C0-BD2867A7EC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F0696-F14C-442F-8BC2-1609E7BA67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802BBD-FC4C-4437-9090-2D55E8321A3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10"/>
          <p:cNvGrpSpPr/>
          <p:nvPr/>
        </p:nvGrpSpPr>
        <p:grpSpPr>
          <a:xfrm>
            <a:off x="552240" y="0"/>
            <a:ext cx="6305400" cy="9728280"/>
            <a:chOff x="552240" y="0"/>
            <a:chExt cx="6305400" cy="9728280"/>
          </a:xfrm>
        </p:grpSpPr>
        <p:grpSp>
          <p:nvGrpSpPr>
            <p:cNvPr id="42" name="Group 103"/>
            <p:cNvGrpSpPr/>
            <p:nvPr/>
          </p:nvGrpSpPr>
          <p:grpSpPr>
            <a:xfrm>
              <a:off x="552240" y="0"/>
              <a:ext cx="6305400" cy="9728280"/>
              <a:chOff x="552240" y="0"/>
              <a:chExt cx="6305400" cy="9728280"/>
            </a:xfrm>
          </p:grpSpPr>
          <p:grpSp>
            <p:nvGrpSpPr>
              <p:cNvPr id="43" name="群組 105"/>
              <p:cNvGrpSpPr/>
              <p:nvPr/>
            </p:nvGrpSpPr>
            <p:grpSpPr>
              <a:xfrm>
                <a:off x="553680" y="6551640"/>
                <a:ext cx="2460600" cy="3165480"/>
                <a:chOff x="553680" y="6551640"/>
                <a:chExt cx="2460600" cy="3165480"/>
              </a:xfrm>
            </p:grpSpPr>
            <p:pic>
              <p:nvPicPr>
                <p:cNvPr id="44" name="Picture 109" descr=""/>
                <p:cNvPicPr/>
                <p:nvPr/>
              </p:nvPicPr>
              <p:blipFill>
                <a:blip r:embed="rId1"/>
                <a:stretch/>
              </p:blipFill>
              <p:spPr>
                <a:xfrm rot="5400000">
                  <a:off x="200880" y="6904080"/>
                  <a:ext cx="3165480" cy="2460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5" name="Text Box 115"/>
                <p:cNvSpPr/>
                <p:nvPr/>
              </p:nvSpPr>
              <p:spPr>
                <a:xfrm rot="5400000">
                  <a:off x="1838880" y="7430760"/>
                  <a:ext cx="385920" cy="236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481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560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" name="Rectangle 113"/>
                <p:cNvSpPr/>
                <p:nvPr/>
              </p:nvSpPr>
              <p:spPr>
                <a:xfrm rot="5400000">
                  <a:off x="2084400" y="7132680"/>
                  <a:ext cx="73440" cy="5796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160" bIns="11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" name="Rectangle 112"/>
                <p:cNvSpPr/>
                <p:nvPr/>
              </p:nvSpPr>
              <p:spPr>
                <a:xfrm rot="5400000">
                  <a:off x="2084400" y="7206120"/>
                  <a:ext cx="73440" cy="5796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160" bIns="11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" name="Rectangle 111"/>
                <p:cNvSpPr/>
                <p:nvPr/>
              </p:nvSpPr>
              <p:spPr>
                <a:xfrm rot="5400000">
                  <a:off x="2000160" y="7311240"/>
                  <a:ext cx="73440" cy="5796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160" bIns="11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Text Box 110"/>
                <p:cNvSpPr/>
                <p:nvPr/>
              </p:nvSpPr>
              <p:spPr>
                <a:xfrm rot="5400000">
                  <a:off x="2000520" y="7190640"/>
                  <a:ext cx="411120" cy="191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3449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" name="Text Box 114"/>
                <p:cNvSpPr/>
                <p:nvPr/>
              </p:nvSpPr>
              <p:spPr>
                <a:xfrm rot="5400000">
                  <a:off x="1835280" y="6960240"/>
                  <a:ext cx="350640" cy="194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3513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1" name="群組 82"/>
              <p:cNvGrpSpPr/>
              <p:nvPr/>
            </p:nvGrpSpPr>
            <p:grpSpPr>
              <a:xfrm>
                <a:off x="552240" y="3375000"/>
                <a:ext cx="2455920" cy="3165480"/>
                <a:chOff x="552240" y="3375000"/>
                <a:chExt cx="2455920" cy="3165480"/>
              </a:xfrm>
            </p:grpSpPr>
            <p:pic>
              <p:nvPicPr>
                <p:cNvPr id="52" name="Picture 74" descr=""/>
                <p:cNvPicPr/>
                <p:nvPr/>
              </p:nvPicPr>
              <p:blipFill>
                <a:blip r:embed="rId2"/>
                <a:stretch/>
              </p:blipFill>
              <p:spPr>
                <a:xfrm rot="5400000">
                  <a:off x="197280" y="3729600"/>
                  <a:ext cx="3165480" cy="2455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3" name="Rectangle 92"/>
                <p:cNvSpPr/>
                <p:nvPr/>
              </p:nvSpPr>
              <p:spPr>
                <a:xfrm rot="5400000">
                  <a:off x="1820520" y="4694760"/>
                  <a:ext cx="73080" cy="7632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Text Box 81"/>
                <p:cNvSpPr/>
                <p:nvPr/>
              </p:nvSpPr>
              <p:spPr>
                <a:xfrm rot="5400000">
                  <a:off x="1706400" y="5604480"/>
                  <a:ext cx="295560" cy="203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47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Rectangle 90"/>
                <p:cNvSpPr/>
                <p:nvPr/>
              </p:nvSpPr>
              <p:spPr>
                <a:xfrm rot="5400000">
                  <a:off x="1917000" y="563076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Rectangle 93"/>
                <p:cNvSpPr/>
                <p:nvPr/>
              </p:nvSpPr>
              <p:spPr>
                <a:xfrm rot="5400000">
                  <a:off x="2032920" y="4763880"/>
                  <a:ext cx="101880" cy="15192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Text Box 80"/>
                <p:cNvSpPr/>
                <p:nvPr/>
              </p:nvSpPr>
              <p:spPr>
                <a:xfrm rot="5400000">
                  <a:off x="1941840" y="5466600"/>
                  <a:ext cx="356400" cy="185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967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Text Box 75"/>
                <p:cNvSpPr/>
                <p:nvPr/>
              </p:nvSpPr>
              <p:spPr>
                <a:xfrm rot="5400000">
                  <a:off x="2081880" y="4828680"/>
                  <a:ext cx="350280" cy="221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937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Text Box 77"/>
                <p:cNvSpPr/>
                <p:nvPr/>
              </p:nvSpPr>
              <p:spPr>
                <a:xfrm rot="5400000">
                  <a:off x="1854360" y="5054040"/>
                  <a:ext cx="336960" cy="133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06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Text Box 76"/>
                <p:cNvSpPr/>
                <p:nvPr/>
              </p:nvSpPr>
              <p:spPr>
                <a:xfrm rot="5400000">
                  <a:off x="2007000" y="4957200"/>
                  <a:ext cx="291600" cy="170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37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Text Box 95"/>
                <p:cNvSpPr/>
                <p:nvPr/>
              </p:nvSpPr>
              <p:spPr>
                <a:xfrm rot="5400000">
                  <a:off x="1951920" y="4545360"/>
                  <a:ext cx="386280" cy="315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04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22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23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27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Rectangle 94"/>
                <p:cNvSpPr/>
                <p:nvPr/>
              </p:nvSpPr>
              <p:spPr>
                <a:xfrm rot="5400000">
                  <a:off x="2156040" y="4894920"/>
                  <a:ext cx="70200" cy="6228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480" bIns="15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Rectangle 85"/>
                <p:cNvSpPr/>
                <p:nvPr/>
              </p:nvSpPr>
              <p:spPr>
                <a:xfrm rot="5400000">
                  <a:off x="2048760" y="4986360"/>
                  <a:ext cx="70200" cy="6228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480" bIns="15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Rectangle 86"/>
                <p:cNvSpPr/>
                <p:nvPr/>
              </p:nvSpPr>
              <p:spPr>
                <a:xfrm rot="5400000">
                  <a:off x="1968480" y="4931280"/>
                  <a:ext cx="70200" cy="6228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480" bIns="15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" name="Rectangle 87"/>
                <p:cNvSpPr/>
                <p:nvPr/>
              </p:nvSpPr>
              <p:spPr>
                <a:xfrm rot="5400000">
                  <a:off x="1829160" y="4852080"/>
                  <a:ext cx="70200" cy="6228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480" bIns="15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Text Box 78"/>
                <p:cNvSpPr/>
                <p:nvPr/>
              </p:nvSpPr>
              <p:spPr>
                <a:xfrm rot="5400000">
                  <a:off x="1558080" y="4808160"/>
                  <a:ext cx="396000" cy="25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21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Rectangle 88"/>
                <p:cNvSpPr/>
                <p:nvPr/>
              </p:nvSpPr>
              <p:spPr>
                <a:xfrm rot="5400000">
                  <a:off x="1616760" y="5045040"/>
                  <a:ext cx="73080" cy="6228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480" bIns="15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" name="Text Box 79"/>
                <p:cNvSpPr/>
                <p:nvPr/>
              </p:nvSpPr>
              <p:spPr>
                <a:xfrm rot="5400000">
                  <a:off x="1369080" y="4948560"/>
                  <a:ext cx="315720" cy="2631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34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" name="Rectangle 89"/>
                <p:cNvSpPr/>
                <p:nvPr/>
              </p:nvSpPr>
              <p:spPr>
                <a:xfrm rot="5400000">
                  <a:off x="1974960" y="553284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" name="Rectangle 91"/>
                <p:cNvSpPr/>
                <p:nvPr/>
              </p:nvSpPr>
              <p:spPr>
                <a:xfrm rot="5400000">
                  <a:off x="1282680" y="4347720"/>
                  <a:ext cx="73080" cy="5760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" name="Text Box 82"/>
                <p:cNvSpPr/>
                <p:nvPr/>
              </p:nvSpPr>
              <p:spPr>
                <a:xfrm rot="5400000">
                  <a:off x="1145520" y="4463280"/>
                  <a:ext cx="370800" cy="179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549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" name="Text Box 83"/>
                <p:cNvSpPr/>
                <p:nvPr/>
              </p:nvSpPr>
              <p:spPr>
                <a:xfrm rot="5400000">
                  <a:off x="1667520" y="4455000"/>
                  <a:ext cx="363960" cy="216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650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3310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73" name="群組 72"/>
              <p:cNvGrpSpPr/>
              <p:nvPr/>
            </p:nvGrpSpPr>
            <p:grpSpPr>
              <a:xfrm>
                <a:off x="552240" y="198720"/>
                <a:ext cx="2455920" cy="3166920"/>
                <a:chOff x="552240" y="198720"/>
                <a:chExt cx="2455920" cy="3166920"/>
              </a:xfrm>
            </p:grpSpPr>
            <p:pic>
              <p:nvPicPr>
                <p:cNvPr id="74" name="Picture 70" descr=""/>
                <p:cNvPicPr/>
                <p:nvPr/>
              </p:nvPicPr>
              <p:blipFill>
                <a:blip r:embed="rId3"/>
                <a:stretch/>
              </p:blipFill>
              <p:spPr>
                <a:xfrm rot="5400000">
                  <a:off x="196560" y="554040"/>
                  <a:ext cx="3166920" cy="2455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5" name="Rectangle 67"/>
                <p:cNvSpPr/>
                <p:nvPr/>
              </p:nvSpPr>
              <p:spPr>
                <a:xfrm rot="5400000">
                  <a:off x="2311920" y="155196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" name="Rectangle 66"/>
                <p:cNvSpPr/>
                <p:nvPr/>
              </p:nvSpPr>
              <p:spPr>
                <a:xfrm rot="5400000">
                  <a:off x="2038320" y="1185120"/>
                  <a:ext cx="73080" cy="5760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" name="Rectangle 64"/>
                <p:cNvSpPr/>
                <p:nvPr/>
              </p:nvSpPr>
              <p:spPr>
                <a:xfrm rot="5400000">
                  <a:off x="1988280" y="1057680"/>
                  <a:ext cx="73080" cy="9432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" name="Text Box 65"/>
                <p:cNvSpPr/>
                <p:nvPr/>
              </p:nvSpPr>
              <p:spPr>
                <a:xfrm rot="5400000">
                  <a:off x="1716120" y="864720"/>
                  <a:ext cx="394920" cy="258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3330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3262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" name="Rectangle 68"/>
                <p:cNvSpPr/>
                <p:nvPr/>
              </p:nvSpPr>
              <p:spPr>
                <a:xfrm rot="5400000">
                  <a:off x="1155600" y="2172960"/>
                  <a:ext cx="73080" cy="5760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" name="Text Box 69"/>
                <p:cNvSpPr/>
                <p:nvPr/>
              </p:nvSpPr>
              <p:spPr>
                <a:xfrm rot="5400000">
                  <a:off x="878040" y="2179800"/>
                  <a:ext cx="435600" cy="179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340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" name="Text Box 69"/>
                <p:cNvSpPr/>
                <p:nvPr/>
              </p:nvSpPr>
              <p:spPr>
                <a:xfrm rot="5400000">
                  <a:off x="2299680" y="1524240"/>
                  <a:ext cx="330840" cy="194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65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" name="Text Box 69"/>
                <p:cNvSpPr/>
                <p:nvPr/>
              </p:nvSpPr>
              <p:spPr>
                <a:xfrm rot="5400000">
                  <a:off x="1993680" y="1269360"/>
                  <a:ext cx="410040" cy="228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598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599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83" name="群組 51"/>
              <p:cNvGrpSpPr/>
              <p:nvPr/>
            </p:nvGrpSpPr>
            <p:grpSpPr>
              <a:xfrm>
                <a:off x="3235320" y="6561360"/>
                <a:ext cx="2469960" cy="3166920"/>
                <a:chOff x="3235320" y="6561360"/>
                <a:chExt cx="2469960" cy="3166920"/>
              </a:xfrm>
            </p:grpSpPr>
            <p:pic>
              <p:nvPicPr>
                <p:cNvPr id="84" name="Picture 1" descr=""/>
                <p:cNvPicPr/>
                <p:nvPr/>
              </p:nvPicPr>
              <p:blipFill>
                <a:blip r:embed="rId4"/>
                <a:stretch/>
              </p:blipFill>
              <p:spPr>
                <a:xfrm rot="5400000">
                  <a:off x="2886480" y="6909840"/>
                  <a:ext cx="3166920" cy="24699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5" name="Text Box 10"/>
                <p:cNvSpPr/>
                <p:nvPr/>
              </p:nvSpPr>
              <p:spPr>
                <a:xfrm rot="5400000">
                  <a:off x="3521520" y="7381080"/>
                  <a:ext cx="367920" cy="163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70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" name="Text Box 5"/>
                <p:cNvSpPr/>
                <p:nvPr/>
              </p:nvSpPr>
              <p:spPr>
                <a:xfrm rot="5400000">
                  <a:off x="3903840" y="8148600"/>
                  <a:ext cx="371160" cy="409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398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399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400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401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" name="Rectangle 19"/>
                <p:cNvSpPr/>
                <p:nvPr/>
              </p:nvSpPr>
              <p:spPr>
                <a:xfrm rot="5400000">
                  <a:off x="4132800" y="8448120"/>
                  <a:ext cx="73440" cy="8964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" name="Rectangle 13"/>
                <p:cNvSpPr/>
                <p:nvPr/>
              </p:nvSpPr>
              <p:spPr>
                <a:xfrm rot="5400000">
                  <a:off x="4390920" y="8556120"/>
                  <a:ext cx="73440" cy="5796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160" bIns="11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" name="Text Box 2"/>
                <p:cNvSpPr/>
                <p:nvPr/>
              </p:nvSpPr>
              <p:spPr>
                <a:xfrm rot="5400000">
                  <a:off x="4354920" y="8499240"/>
                  <a:ext cx="335160" cy="145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633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" name="Rectangle 14"/>
                <p:cNvSpPr/>
                <p:nvPr/>
              </p:nvSpPr>
              <p:spPr>
                <a:xfrm rot="5400000">
                  <a:off x="4132800" y="8521920"/>
                  <a:ext cx="73440" cy="89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" name="Text Box 20"/>
                <p:cNvSpPr/>
                <p:nvPr/>
              </p:nvSpPr>
              <p:spPr>
                <a:xfrm rot="5400000">
                  <a:off x="3909240" y="8541000"/>
                  <a:ext cx="353520" cy="167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578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" name="Rectangle 15"/>
                <p:cNvSpPr/>
                <p:nvPr/>
              </p:nvSpPr>
              <p:spPr>
                <a:xfrm rot="5400000">
                  <a:off x="4316040" y="8381520"/>
                  <a:ext cx="73440" cy="89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" name="Text Box 6"/>
                <p:cNvSpPr/>
                <p:nvPr/>
              </p:nvSpPr>
              <p:spPr>
                <a:xfrm rot="5400000">
                  <a:off x="4272120" y="8379000"/>
                  <a:ext cx="365400" cy="15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54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" name="Rectangle 16"/>
                <p:cNvSpPr/>
                <p:nvPr/>
              </p:nvSpPr>
              <p:spPr>
                <a:xfrm rot="5400000">
                  <a:off x="4141080" y="7914600"/>
                  <a:ext cx="73440" cy="990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" name="Rectangle 17"/>
                <p:cNvSpPr/>
                <p:nvPr/>
              </p:nvSpPr>
              <p:spPr>
                <a:xfrm rot="5400000">
                  <a:off x="4006440" y="8029440"/>
                  <a:ext cx="73440" cy="990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6" name="Rectangle 11"/>
                <p:cNvSpPr/>
                <p:nvPr/>
              </p:nvSpPr>
              <p:spPr>
                <a:xfrm rot="5400000">
                  <a:off x="3736800" y="7904160"/>
                  <a:ext cx="73440" cy="990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7" name="Rectangle 12"/>
                <p:cNvSpPr/>
                <p:nvPr/>
              </p:nvSpPr>
              <p:spPr>
                <a:xfrm rot="5400000">
                  <a:off x="3794760" y="7387920"/>
                  <a:ext cx="73440" cy="990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8" name="Text Box 9"/>
                <p:cNvSpPr/>
                <p:nvPr/>
              </p:nvSpPr>
              <p:spPr>
                <a:xfrm rot="5400000">
                  <a:off x="3483360" y="7884720"/>
                  <a:ext cx="330840" cy="178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39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9" name="Text Box 8"/>
                <p:cNvSpPr/>
                <p:nvPr/>
              </p:nvSpPr>
              <p:spPr>
                <a:xfrm rot="5400000">
                  <a:off x="3754800" y="8037720"/>
                  <a:ext cx="369360" cy="175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98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0" name="Text Box 7"/>
                <p:cNvSpPr/>
                <p:nvPr/>
              </p:nvSpPr>
              <p:spPr>
                <a:xfrm rot="5400000">
                  <a:off x="4116240" y="7899480"/>
                  <a:ext cx="361080" cy="179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99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01" name="群組 88"/>
              <p:cNvGrpSpPr/>
              <p:nvPr/>
            </p:nvGrpSpPr>
            <p:grpSpPr>
              <a:xfrm>
                <a:off x="3209760" y="3386160"/>
                <a:ext cx="2552760" cy="3165480"/>
                <a:chOff x="3209760" y="3386160"/>
                <a:chExt cx="2552760" cy="3165480"/>
              </a:xfrm>
            </p:grpSpPr>
            <p:sp>
              <p:nvSpPr>
                <p:cNvPr id="102" name="文字方塊 10"/>
                <p:cNvSpPr/>
                <p:nvPr/>
              </p:nvSpPr>
              <p:spPr>
                <a:xfrm rot="5400000">
                  <a:off x="3974760" y="5194800"/>
                  <a:ext cx="54576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(iii) PA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pic>
              <p:nvPicPr>
                <p:cNvPr id="103" name="Picture 69" descr=""/>
                <p:cNvPicPr/>
                <p:nvPr/>
              </p:nvPicPr>
              <p:blipFill>
                <a:blip r:embed="rId5"/>
                <a:stretch/>
              </p:blipFill>
              <p:spPr>
                <a:xfrm rot="5400000">
                  <a:off x="2903040" y="3692520"/>
                  <a:ext cx="3165480" cy="25527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4" name="Rectangle 75"/>
                <p:cNvSpPr/>
                <p:nvPr/>
              </p:nvSpPr>
              <p:spPr>
                <a:xfrm rot="5400000">
                  <a:off x="4646880" y="576900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5" name="Text Box 88"/>
                <p:cNvSpPr/>
                <p:nvPr/>
              </p:nvSpPr>
              <p:spPr>
                <a:xfrm rot="5400000">
                  <a:off x="4347720" y="5744160"/>
                  <a:ext cx="399600" cy="245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3363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6" name="Rectangle 76"/>
                <p:cNvSpPr/>
                <p:nvPr/>
              </p:nvSpPr>
              <p:spPr>
                <a:xfrm rot="5400000">
                  <a:off x="4493880" y="525708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7" name="Text Box 87"/>
                <p:cNvSpPr/>
                <p:nvPr/>
              </p:nvSpPr>
              <p:spPr>
                <a:xfrm rot="5400000">
                  <a:off x="3889440" y="6071760"/>
                  <a:ext cx="371520" cy="19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577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8" name="Text Box 84"/>
                <p:cNvSpPr/>
                <p:nvPr/>
              </p:nvSpPr>
              <p:spPr>
                <a:xfrm rot="5400000">
                  <a:off x="4020480" y="4931640"/>
                  <a:ext cx="414360" cy="170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95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9" name="Rectangle 70"/>
                <p:cNvSpPr/>
                <p:nvPr/>
              </p:nvSpPr>
              <p:spPr>
                <a:xfrm rot="5400000">
                  <a:off x="4263480" y="4211280"/>
                  <a:ext cx="73080" cy="5760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0" name="Text Box 83"/>
                <p:cNvSpPr/>
                <p:nvPr/>
              </p:nvSpPr>
              <p:spPr>
                <a:xfrm rot="5400000">
                  <a:off x="4127400" y="3960720"/>
                  <a:ext cx="353880" cy="19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785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1" name="Rectangle 71"/>
                <p:cNvSpPr/>
                <p:nvPr/>
              </p:nvSpPr>
              <p:spPr>
                <a:xfrm rot="5400000">
                  <a:off x="4205520" y="4229280"/>
                  <a:ext cx="73080" cy="5760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" name="Text Box 82"/>
                <p:cNvSpPr/>
                <p:nvPr/>
              </p:nvSpPr>
              <p:spPr>
                <a:xfrm rot="5400000">
                  <a:off x="4059360" y="3957480"/>
                  <a:ext cx="353880" cy="2001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718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3" name="Rectangle 72"/>
                <p:cNvSpPr/>
                <p:nvPr/>
              </p:nvSpPr>
              <p:spPr>
                <a:xfrm rot="5400000">
                  <a:off x="4114080" y="4320720"/>
                  <a:ext cx="73080" cy="5760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4" name="Text Box 81"/>
                <p:cNvSpPr/>
                <p:nvPr/>
              </p:nvSpPr>
              <p:spPr>
                <a:xfrm rot="5400000">
                  <a:off x="3862440" y="4244040"/>
                  <a:ext cx="355320" cy="203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610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" name="Rectangle 73"/>
                <p:cNvSpPr/>
                <p:nvPr/>
              </p:nvSpPr>
              <p:spPr>
                <a:xfrm rot="5400000">
                  <a:off x="4163400" y="4408560"/>
                  <a:ext cx="73080" cy="5760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6" name="Text Box 74"/>
                <p:cNvSpPr/>
                <p:nvPr/>
              </p:nvSpPr>
              <p:spPr>
                <a:xfrm rot="5400000">
                  <a:off x="4002480" y="4528800"/>
                  <a:ext cx="377280" cy="183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429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7" name="Rectangle 77"/>
                <p:cNvSpPr/>
                <p:nvPr/>
              </p:nvSpPr>
              <p:spPr>
                <a:xfrm rot="5400000">
                  <a:off x="4325760" y="513900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" name="Rectangle 78"/>
                <p:cNvSpPr/>
                <p:nvPr/>
              </p:nvSpPr>
              <p:spPr>
                <a:xfrm rot="5400000">
                  <a:off x="4284000" y="492264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9" name="Rectangle 79"/>
                <p:cNvSpPr/>
                <p:nvPr/>
              </p:nvSpPr>
              <p:spPr>
                <a:xfrm rot="5400000">
                  <a:off x="4142880" y="609588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0" name="Text Box 85"/>
                <p:cNvSpPr/>
                <p:nvPr/>
              </p:nvSpPr>
              <p:spPr>
                <a:xfrm rot="5400000">
                  <a:off x="4132080" y="5083200"/>
                  <a:ext cx="265320" cy="187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36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" name="Text Box 86"/>
                <p:cNvSpPr/>
                <p:nvPr/>
              </p:nvSpPr>
              <p:spPr>
                <a:xfrm rot="5400000">
                  <a:off x="4260960" y="5237640"/>
                  <a:ext cx="336240" cy="184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094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22" name="群組 58"/>
              <p:cNvGrpSpPr/>
              <p:nvPr/>
            </p:nvGrpSpPr>
            <p:grpSpPr>
              <a:xfrm>
                <a:off x="3233880" y="219240"/>
                <a:ext cx="2528640" cy="3155760"/>
                <a:chOff x="3233880" y="219240"/>
                <a:chExt cx="2528640" cy="3155760"/>
              </a:xfrm>
            </p:grpSpPr>
            <p:pic>
              <p:nvPicPr>
                <p:cNvPr id="123" name="Picture 51" descr=""/>
                <p:cNvPicPr/>
                <p:nvPr/>
              </p:nvPicPr>
              <p:blipFill>
                <a:blip r:embed="rId6"/>
                <a:stretch/>
              </p:blipFill>
              <p:spPr>
                <a:xfrm rot="5400000">
                  <a:off x="2919960" y="532440"/>
                  <a:ext cx="3155760" cy="25286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4" name="Rectangle 52"/>
                <p:cNvSpPr/>
                <p:nvPr/>
              </p:nvSpPr>
              <p:spPr>
                <a:xfrm rot="5400000">
                  <a:off x="4811760" y="144612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5" name="Rectangle 53"/>
                <p:cNvSpPr/>
                <p:nvPr/>
              </p:nvSpPr>
              <p:spPr>
                <a:xfrm rot="5400000">
                  <a:off x="4710240" y="1701360"/>
                  <a:ext cx="74880" cy="1026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6" name="Rectangle 55"/>
                <p:cNvSpPr/>
                <p:nvPr/>
              </p:nvSpPr>
              <p:spPr>
                <a:xfrm rot="5400000">
                  <a:off x="4473000" y="1927440"/>
                  <a:ext cx="73080" cy="7632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7" name="Rectangle 54"/>
                <p:cNvSpPr/>
                <p:nvPr/>
              </p:nvSpPr>
              <p:spPr>
                <a:xfrm rot="5400000">
                  <a:off x="4325040" y="2088360"/>
                  <a:ext cx="127080" cy="6696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8" name="Rectangle 56"/>
                <p:cNvSpPr/>
                <p:nvPr/>
              </p:nvSpPr>
              <p:spPr>
                <a:xfrm rot="5400000">
                  <a:off x="4226400" y="2087280"/>
                  <a:ext cx="73080" cy="986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9" name="Text Box 57"/>
                <p:cNvSpPr/>
                <p:nvPr/>
              </p:nvSpPr>
              <p:spPr>
                <a:xfrm rot="5400000">
                  <a:off x="4486320" y="1697040"/>
                  <a:ext cx="410760" cy="19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623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0" name="Text Box 63"/>
                <p:cNvSpPr/>
                <p:nvPr/>
              </p:nvSpPr>
              <p:spPr>
                <a:xfrm rot="5400000">
                  <a:off x="4419720" y="1846440"/>
                  <a:ext cx="307800" cy="234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490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1" name="Text Box 59"/>
                <p:cNvSpPr/>
                <p:nvPr/>
              </p:nvSpPr>
              <p:spPr>
                <a:xfrm rot="5400000">
                  <a:off x="4212360" y="2277360"/>
                  <a:ext cx="427320" cy="208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792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793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2" name="Text Box 65"/>
                <p:cNvSpPr/>
                <p:nvPr/>
              </p:nvSpPr>
              <p:spPr>
                <a:xfrm rot="5400000">
                  <a:off x="3954960" y="2022840"/>
                  <a:ext cx="357120" cy="216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1154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Calibri"/>
                      <a:ea typeface="新細明體"/>
                    </a:rPr>
                    <a:t>2111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3" name="Text Box 62"/>
                <p:cNvSpPr/>
                <p:nvPr/>
              </p:nvSpPr>
              <p:spPr>
                <a:xfrm rot="5400000">
                  <a:off x="4861440" y="1347120"/>
                  <a:ext cx="412920" cy="36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474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778,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ff0000"/>
                      </a:solidFill>
                      <a:latin typeface="Calibri"/>
                      <a:ea typeface="新細明體"/>
                    </a:rPr>
                    <a:t>2779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34" name="Rectangle 13"/>
              <p:cNvSpPr/>
              <p:nvPr/>
            </p:nvSpPr>
            <p:spPr>
              <a:xfrm rot="5400000">
                <a:off x="1803240" y="4971600"/>
                <a:ext cx="9072720" cy="253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3880" rIns="83880" tIns="42120" bIns="42120" anchor="ctr">
                <a:spAutoFit/>
              </a:bodyPr>
              <a:p>
                <a:pPr>
                  <a:tabLst>
                    <a:tab algn="l" pos="0"/>
                    <a:tab algn="l" pos="577800"/>
                    <a:tab algn="l" pos="272736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文字方塊 22"/>
              <p:cNvSpPr/>
              <p:nvPr/>
            </p:nvSpPr>
            <p:spPr>
              <a:xfrm rot="5400000">
                <a:off x="5335560" y="758880"/>
                <a:ext cx="842760" cy="25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3880" rIns="83880" tIns="42120" bIns="4212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(i) PB2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文字方塊 28"/>
              <p:cNvSpPr/>
              <p:nvPr/>
            </p:nvSpPr>
            <p:spPr>
              <a:xfrm rot="5400000">
                <a:off x="5335560" y="3952800"/>
                <a:ext cx="842760" cy="25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3880" rIns="83880" tIns="42120" bIns="4212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(ii) PB1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文字方塊 15"/>
              <p:cNvSpPr/>
              <p:nvPr/>
            </p:nvSpPr>
            <p:spPr>
              <a:xfrm rot="5400000">
                <a:off x="2662200" y="758880"/>
                <a:ext cx="842760" cy="25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3880" rIns="83880" tIns="42120" bIns="4212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(iv) HA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文字方塊 15"/>
              <p:cNvSpPr/>
              <p:nvPr/>
            </p:nvSpPr>
            <p:spPr>
              <a:xfrm rot="5400000">
                <a:off x="2662200" y="3952800"/>
                <a:ext cx="842760" cy="25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3880" rIns="83880" tIns="42120" bIns="4212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(v) NP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文字方塊 15"/>
              <p:cNvSpPr/>
              <p:nvPr/>
            </p:nvSpPr>
            <p:spPr>
              <a:xfrm rot="5400000">
                <a:off x="2662200" y="7112160"/>
                <a:ext cx="842760" cy="25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3880" rIns="83880" tIns="42120" bIns="4212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(vi) NA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Rectangle 66"/>
              <p:cNvSpPr/>
              <p:nvPr/>
            </p:nvSpPr>
            <p:spPr>
              <a:xfrm rot="5400000">
                <a:off x="6591960" y="-96120"/>
                <a:ext cx="169560" cy="36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3880" rIns="83880" tIns="42120" bIns="4212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Rectangle 67"/>
              <p:cNvSpPr/>
              <p:nvPr/>
            </p:nvSpPr>
            <p:spPr>
              <a:xfrm rot="5400000">
                <a:off x="6177960" y="-96120"/>
                <a:ext cx="169560" cy="36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3880" rIns="83880" tIns="42120" bIns="4212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Rectangle 89"/>
              <p:cNvSpPr/>
              <p:nvPr/>
            </p:nvSpPr>
            <p:spPr>
              <a:xfrm rot="5400000">
                <a:off x="6591960" y="-96120"/>
                <a:ext cx="169560" cy="36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3880" rIns="83880" tIns="42120" bIns="4212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Rectangle 90"/>
              <p:cNvSpPr/>
              <p:nvPr/>
            </p:nvSpPr>
            <p:spPr>
              <a:xfrm rot="5400000">
                <a:off x="6177960" y="-96120"/>
                <a:ext cx="169560" cy="36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3880" rIns="83880" tIns="42120" bIns="4212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文字方塊 28"/>
              <p:cNvSpPr/>
              <p:nvPr/>
            </p:nvSpPr>
            <p:spPr>
              <a:xfrm rot="5400000">
                <a:off x="5343480" y="7112160"/>
                <a:ext cx="842760" cy="25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3880" rIns="83880" tIns="42120" bIns="4212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(iii) PA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45" name="Rectangle 5"/>
            <p:cNvSpPr/>
            <p:nvPr/>
          </p:nvSpPr>
          <p:spPr>
            <a:xfrm>
              <a:off x="5562720" y="1066680"/>
              <a:ext cx="304560" cy="1676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Rectangle 6"/>
            <p:cNvSpPr/>
            <p:nvPr/>
          </p:nvSpPr>
          <p:spPr>
            <a:xfrm>
              <a:off x="5639040" y="4343400"/>
              <a:ext cx="304560" cy="1676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Rectangle 7"/>
            <p:cNvSpPr/>
            <p:nvPr/>
          </p:nvSpPr>
          <p:spPr>
            <a:xfrm>
              <a:off x="5562720" y="7467840"/>
              <a:ext cx="304560" cy="1676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Rectangle 8"/>
            <p:cNvSpPr/>
            <p:nvPr/>
          </p:nvSpPr>
          <p:spPr>
            <a:xfrm>
              <a:off x="2895480" y="1295280"/>
              <a:ext cx="304560" cy="1676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Rectangle 9"/>
            <p:cNvSpPr/>
            <p:nvPr/>
          </p:nvSpPr>
          <p:spPr>
            <a:xfrm>
              <a:off x="2895480" y="4267080"/>
              <a:ext cx="304560" cy="1676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Rectangle 10"/>
            <p:cNvSpPr/>
            <p:nvPr/>
          </p:nvSpPr>
          <p:spPr>
            <a:xfrm>
              <a:off x="2895480" y="7543800"/>
              <a:ext cx="304560" cy="1676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1" name="Rectangle 111"/>
          <p:cNvSpPr/>
          <p:nvPr/>
        </p:nvSpPr>
        <p:spPr>
          <a:xfrm rot="5400000">
            <a:off x="1758240" y="4765680"/>
            <a:ext cx="913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gure 2. Representative outliers of host or subtype groups in the CA for each viral gene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Outliers are enclosed by open-boxes. Sequence numbers of outliers are indicated (see Table S1). Avian virus outliers are marked in red, while human virus outliers are in black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4T04:16:50Z</dcterms:created>
  <dc:creator>llmpoon</dc:creator>
  <dc:description/>
  <dc:language>en-US</dc:language>
  <cp:lastModifiedBy>llmpoon</cp:lastModifiedBy>
  <dcterms:modified xsi:type="dcterms:W3CDTF">2010-04-14T04:17:23Z</dcterms:modified>
  <cp:revision>1</cp:revision>
  <dc:subject/>
  <dc:title>Slide 1</dc:title>
</cp:coreProperties>
</file>